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60" d="100"/>
          <a:sy n="60" d="100"/>
        </p:scale>
        <p:origin x="84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D3EC943F-52FC-D7F8-A380-D2D9D7EF22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50F826F1-ABDA-F4DA-A929-D9C177D0B2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345E747-46D2-1765-A939-A1F2D49A38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4628DCF-A074-E1AA-0809-E0C9A8D876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0916540-79D3-C742-B223-F844055440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984953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CF59CB3-8468-199E-0DB9-8C683A8BD3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1DA749DC-8883-B272-BA4E-3C5205EDEF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D4D9EF65-562D-4B04-D794-D2AB66A079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4C35181-C7E8-BF49-FC20-EE2103A67C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AF2DBC5-ACC5-CBB5-9F0C-1083B54A64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04975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7B92292E-B79C-C529-A509-873CB4E44D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DD5DECC4-1065-BA5D-F1F5-EB21371E9F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B36F2F6-4399-94DA-AF84-0C88778D6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35995ED8-AA95-8C9F-97BD-99DE6B055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9DC233E-C1EC-57FA-0106-71023F960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0791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600C7121-DE69-534A-0013-0C184A0C31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CCD37D77-D57F-09BA-E2B1-25C6C0B582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24EB54A-14F1-52DB-86E1-92B08303B3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B28BD21-DFF2-A385-D437-5FAF14FCF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5D81605-17EE-57E2-E157-DBD027CE6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74830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69135B8-B501-C6B3-5FE7-BFF7D5517A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06F100F9-FC97-8810-D66E-4D6E867CD8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4D47574-BF86-C290-4F05-F64CD9239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00AB86ED-17AD-39B8-E9DD-0AB43CB059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98140465-43DF-F3CA-B7A3-96E35E078B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617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1FF58A6-579C-F8DF-59C6-CBA4971D6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FD9F311B-5D4F-BAA6-D0F1-5B0D5F607A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7877E51E-5550-41F6-829D-C710F689EE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7609D39A-5467-D0B1-338B-5FC2A57DAC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49B5802-B03F-ECB5-696C-7BC6CC24DA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90203AA1-085A-0590-7EB0-47AAF9D58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50713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A34F1F8-2814-0147-7AB6-BEDAB8E782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6E0D564F-31D6-A507-04EA-3B9D9A60AD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238F2CE8-3B2D-F8A8-DAC0-EBFFE49AD72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E5D879A5-E11A-CF12-CA92-A4E6560829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E170CCAC-B504-B4DF-7213-305ADBB662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99F07C71-A81D-20DF-8425-8D8402F6B9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F021F1BF-0219-C9B2-A458-6ACDB48C6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87845220-F777-E1B7-6EF5-A591A704CE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53644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BD3CEA79-FA51-EAEC-0F8F-416D52FF71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755DED52-144F-3B51-12AE-E9696A5632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E414DE35-BB9A-7444-3614-3D838EE27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274275F9-4EDC-6D7B-924B-1AC2039753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2802332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FF5BBD88-B556-B1A1-B841-B8FBDA087B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CF4D31AC-D348-11AF-DD41-B9C0D5AE9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085229DF-02AB-FE5E-28F3-89FC65F3D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351805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0E6564B-567D-0875-89E2-D267FD2C8A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D36B796-D331-1373-F0AE-58B21F470E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5FCA7286-166F-6D30-9B9F-29F050DD2A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55A9CDC1-7614-6902-4970-FB82AE32B0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B08AF9FD-2CD2-170E-F601-F2D270D2C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4FD21010-99AB-98C7-0481-7BE36F7CCB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112636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340FC14B-2BDC-4BCA-0406-36DD50451E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A9FB4B72-C169-4D3D-7B59-6A32827201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F74F1275-C51C-B1C6-5CC8-25AE563A35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CA1C198-B2FE-BB3A-AF83-6B2F558B3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685B4827-E8C2-622D-58E3-8CBF288AFC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3E62F4E3-6761-EB94-976F-D0485CD4E1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850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5A82C844-3809-E7A6-8D15-B830F3356A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9FB5DE4-9FEC-1DF7-8905-64D0DCE476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2EF7E091-D678-4E53-364F-48F063E120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140EE6-02C9-4D99-B9BB-BEA59C6817B7}" type="datetimeFigureOut">
              <a:rPr lang="zh-TW" altLang="en-US" smtClean="0"/>
              <a:t>2023/9/12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88954F1-B0BF-FED2-CEE9-ABBE3EADDA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BFBB231-CD2F-70C7-8793-71A9156913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AC489E-97DA-4547-9B52-54986F57551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13151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標題 1">
            <a:extLst>
              <a:ext uri="{FF2B5EF4-FFF2-40B4-BE49-F238E27FC236}">
                <a16:creationId xmlns:a16="http://schemas.microsoft.com/office/drawing/2014/main" id="{AD85A5FB-4EB6-475E-39C0-997F7555A7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Autofit/>
          </a:bodyPr>
          <a:lstStyle/>
          <a:p>
            <a:r>
              <a:rPr lang="en-US" altLang="zh-TW" sz="2000" dirty="0"/>
              <a:t>Supplement Table 4. Pixel-level confusion matrix. (a) count by pixel. (b) Calculated by longitudinal axis. Most of the mis-classified pixels for ground truth were classified as background. (c) Calculated by vertical axis. Most of the mis-classified pixels for label were classified as background, but P and ENE has more cross-mistake.</a:t>
            </a:r>
            <a:endParaRPr lang="zh-TW" altLang="en-US" sz="2000" dirty="0"/>
          </a:p>
        </p:txBody>
      </p:sp>
      <p:graphicFrame>
        <p:nvGraphicFramePr>
          <p:cNvPr id="8" name="表格 7">
            <a:extLst>
              <a:ext uri="{FF2B5EF4-FFF2-40B4-BE49-F238E27FC236}">
                <a16:creationId xmlns:a16="http://schemas.microsoft.com/office/drawing/2014/main" id="{34137985-EC51-AE5F-24DA-8B7F485A387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19251961"/>
              </p:ext>
            </p:extLst>
          </p:nvPr>
        </p:nvGraphicFramePr>
        <p:xfrm>
          <a:off x="838201" y="2035360"/>
          <a:ext cx="4851011" cy="1153685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70085">
                  <a:extLst>
                    <a:ext uri="{9D8B030D-6E8A-4147-A177-3AD203B41FA5}">
                      <a16:colId xmlns:a16="http://schemas.microsoft.com/office/drawing/2014/main" val="802757678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847718146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1404602594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3065350954"/>
                    </a:ext>
                  </a:extLst>
                </a:gridCol>
                <a:gridCol w="970671">
                  <a:extLst>
                    <a:ext uri="{9D8B030D-6E8A-4147-A177-3AD203B41FA5}">
                      <a16:colId xmlns:a16="http://schemas.microsoft.com/office/drawing/2014/main" val="2076249749"/>
                    </a:ext>
                  </a:extLst>
                </a:gridCol>
              </a:tblGrid>
              <a:tr h="384561">
                <a:tc>
                  <a:txBody>
                    <a:bodyPr/>
                    <a:lstStyle/>
                    <a:p>
                      <a:pPr algn="r"/>
                      <a:r>
                        <a:rPr lang="en-US" sz="1200" u="none" kern="100">
                          <a:effectLst/>
                        </a:rPr>
                        <a:t>pred</a:t>
                      </a:r>
                      <a:endParaRPr lang="zh-TW" sz="1200" u="none" kern="100">
                        <a:effectLst/>
                      </a:endParaRPr>
                    </a:p>
                    <a:p>
                      <a:pPr algn="just"/>
                      <a:r>
                        <a:rPr lang="en-US" sz="1200" u="none" kern="100">
                          <a:effectLst/>
                        </a:rPr>
                        <a:t>GT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 anchor="b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background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ENE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N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P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2717385060"/>
                  </a:ext>
                </a:extLst>
              </a:tr>
              <a:tr h="192281"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background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193608232</a:t>
                      </a:r>
                      <a:endParaRPr lang="zh-TW" sz="1200" u="none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21642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67878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effectLst/>
                        </a:rPr>
                        <a:t>29089</a:t>
                      </a:r>
                      <a:endParaRPr lang="zh-TW" sz="1200" u="none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754611484"/>
                  </a:ext>
                </a:extLst>
              </a:tr>
              <a:tr h="192281"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ENE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effectLst/>
                        </a:rPr>
                        <a:t>82413</a:t>
                      </a:r>
                      <a:endParaRPr lang="zh-TW" sz="1200" u="none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118274</a:t>
                      </a:r>
                      <a:endParaRPr lang="zh-TW" sz="1200" u="none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0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effectLst/>
                        </a:rPr>
                        <a:t>14090</a:t>
                      </a:r>
                      <a:endParaRPr lang="zh-TW" sz="1200" u="none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3445154355"/>
                  </a:ext>
                </a:extLst>
              </a:tr>
              <a:tr h="192281"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N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effectLst/>
                        </a:rPr>
                        <a:t>60811</a:t>
                      </a:r>
                      <a:endParaRPr lang="zh-TW" sz="1200" u="none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34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108723</a:t>
                      </a:r>
                      <a:endParaRPr lang="zh-TW" sz="1200" u="none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13712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3868084093"/>
                  </a:ext>
                </a:extLst>
              </a:tr>
              <a:tr h="192281"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P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32789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effectLst/>
                        </a:rPr>
                        <a:t>17146</a:t>
                      </a:r>
                      <a:endParaRPr lang="zh-TW" sz="1200" u="none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>
                          <a:effectLst/>
                        </a:rPr>
                        <a:t>3305</a:t>
                      </a:r>
                      <a:endParaRPr lang="zh-TW" sz="1200" u="none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70566</a:t>
                      </a:r>
                      <a:endParaRPr lang="zh-TW" sz="1200" u="none" kern="100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6782473"/>
                  </a:ext>
                </a:extLst>
              </a:tr>
            </a:tbl>
          </a:graphicData>
        </a:graphic>
      </p:graphicFrame>
      <p:sp>
        <p:nvSpPr>
          <p:cNvPr id="9" name="文字方塊 8">
            <a:extLst>
              <a:ext uri="{FF2B5EF4-FFF2-40B4-BE49-F238E27FC236}">
                <a16:creationId xmlns:a16="http://schemas.microsoft.com/office/drawing/2014/main" id="{F7009B7C-B016-DD56-C3F3-0BA474FB0D5C}"/>
              </a:ext>
            </a:extLst>
          </p:cNvPr>
          <p:cNvSpPr txBox="1"/>
          <p:nvPr/>
        </p:nvSpPr>
        <p:spPr>
          <a:xfrm>
            <a:off x="838201" y="1748868"/>
            <a:ext cx="1387498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46" dirty="0"/>
              <a:t>(a) Count by pixel</a:t>
            </a:r>
            <a:endParaRPr lang="zh-TW" altLang="en-US" sz="1246" dirty="0"/>
          </a:p>
        </p:txBody>
      </p:sp>
      <p:graphicFrame>
        <p:nvGraphicFramePr>
          <p:cNvPr id="10" name="表格 9">
            <a:extLst>
              <a:ext uri="{FF2B5EF4-FFF2-40B4-BE49-F238E27FC236}">
                <a16:creationId xmlns:a16="http://schemas.microsoft.com/office/drawing/2014/main" id="{FAFFD393-F3F6-4DFF-791A-57D9F0B110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3519899"/>
              </p:ext>
            </p:extLst>
          </p:nvPr>
        </p:nvGraphicFramePr>
        <p:xfrm>
          <a:off x="838200" y="3671050"/>
          <a:ext cx="4851009" cy="1139484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70085">
                  <a:extLst>
                    <a:ext uri="{9D8B030D-6E8A-4147-A177-3AD203B41FA5}">
                      <a16:colId xmlns:a16="http://schemas.microsoft.com/office/drawing/2014/main" val="2727862437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318062726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2453441078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1033495086"/>
                    </a:ext>
                  </a:extLst>
                </a:gridCol>
                <a:gridCol w="970669">
                  <a:extLst>
                    <a:ext uri="{9D8B030D-6E8A-4147-A177-3AD203B41FA5}">
                      <a16:colId xmlns:a16="http://schemas.microsoft.com/office/drawing/2014/main" val="1542801713"/>
                    </a:ext>
                  </a:extLst>
                </a:gridCol>
              </a:tblGrid>
              <a:tr h="379828">
                <a:tc>
                  <a:txBody>
                    <a:bodyPr/>
                    <a:lstStyle/>
                    <a:p>
                      <a:pPr marL="0" algn="r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re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algn="just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GT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 anchor="b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backgroun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ENE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1994193744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backgroun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99.94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1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4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2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1673604269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ENE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38.37 %</a:t>
                      </a:r>
                      <a:endParaRPr lang="zh-TW" altLang="en-US" sz="1200" u="none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55.07 %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6.56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2675973485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33.18 %</a:t>
                      </a:r>
                      <a:endParaRPr lang="zh-TW" altLang="en-US" sz="1200" u="none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2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59.32 %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7.48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2086992290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26.48 %</a:t>
                      </a:r>
                      <a:endParaRPr lang="zh-TW" altLang="en-US" sz="1200" u="none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13.85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2.67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57.00 %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87077279"/>
                  </a:ext>
                </a:extLst>
              </a:tr>
            </a:tbl>
          </a:graphicData>
        </a:graphic>
      </p:graphicFrame>
      <p:sp>
        <p:nvSpPr>
          <p:cNvPr id="11" name="文字方塊 10">
            <a:extLst>
              <a:ext uri="{FF2B5EF4-FFF2-40B4-BE49-F238E27FC236}">
                <a16:creationId xmlns:a16="http://schemas.microsoft.com/office/drawing/2014/main" id="{B7A57F55-B3A3-594C-48F1-892286527B56}"/>
              </a:ext>
            </a:extLst>
          </p:cNvPr>
          <p:cNvSpPr txBox="1"/>
          <p:nvPr/>
        </p:nvSpPr>
        <p:spPr>
          <a:xfrm>
            <a:off x="838200" y="3436686"/>
            <a:ext cx="248882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46" dirty="0"/>
              <a:t>(b) Calculated by longitudinal axis</a:t>
            </a:r>
            <a:endParaRPr lang="zh-TW" altLang="en-US" sz="1246" dirty="0"/>
          </a:p>
        </p:txBody>
      </p:sp>
      <p:graphicFrame>
        <p:nvGraphicFramePr>
          <p:cNvPr id="12" name="表格 11">
            <a:extLst>
              <a:ext uri="{FF2B5EF4-FFF2-40B4-BE49-F238E27FC236}">
                <a16:creationId xmlns:a16="http://schemas.microsoft.com/office/drawing/2014/main" id="{18651F4F-7B01-DF6E-FA6E-3CB54E47930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89263172"/>
              </p:ext>
            </p:extLst>
          </p:nvPr>
        </p:nvGraphicFramePr>
        <p:xfrm>
          <a:off x="838200" y="5353391"/>
          <a:ext cx="4851010" cy="1139484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970085">
                  <a:extLst>
                    <a:ext uri="{9D8B030D-6E8A-4147-A177-3AD203B41FA5}">
                      <a16:colId xmlns:a16="http://schemas.microsoft.com/office/drawing/2014/main" val="499214389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1290438987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3237906866"/>
                    </a:ext>
                  </a:extLst>
                </a:gridCol>
                <a:gridCol w="970085">
                  <a:extLst>
                    <a:ext uri="{9D8B030D-6E8A-4147-A177-3AD203B41FA5}">
                      <a16:colId xmlns:a16="http://schemas.microsoft.com/office/drawing/2014/main" val="2505224940"/>
                    </a:ext>
                  </a:extLst>
                </a:gridCol>
                <a:gridCol w="970670">
                  <a:extLst>
                    <a:ext uri="{9D8B030D-6E8A-4147-A177-3AD203B41FA5}">
                      <a16:colId xmlns:a16="http://schemas.microsoft.com/office/drawing/2014/main" val="3767646357"/>
                    </a:ext>
                  </a:extLst>
                </a:gridCol>
              </a:tblGrid>
              <a:tr h="379828">
                <a:tc>
                  <a:txBody>
                    <a:bodyPr/>
                    <a:lstStyle/>
                    <a:p>
                      <a:pPr marL="0" algn="r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re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 marL="0" algn="just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GT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 anchor="b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backgroun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ENE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2807249242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background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99.91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13.78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37.73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22.82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2790912672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ENE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4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75.29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11.05 %</a:t>
                      </a:r>
                      <a:endParaRPr lang="zh-TW" altLang="en-US" sz="1200" u="none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967027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N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3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2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60.43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10.76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1388321829"/>
                  </a:ext>
                </a:extLst>
              </a:tr>
              <a:tr h="189914"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P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>
                          <a:solidFill>
                            <a:schemeClr val="tx1"/>
                          </a:solidFill>
                          <a:effectLst/>
                        </a:rPr>
                        <a:t>0.02 %</a:t>
                      </a:r>
                      <a:endParaRPr lang="zh-TW" altLang="en-US" sz="1200" u="none" kern="1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bg1"/>
                          </a:solidFill>
                          <a:effectLst/>
                        </a:rPr>
                        <a:t>10.91 %</a:t>
                      </a:r>
                      <a:endParaRPr lang="zh-TW" altLang="en-US" sz="1200" u="none" kern="100" dirty="0">
                        <a:solidFill>
                          <a:schemeClr val="bg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1.84 %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tc>
                  <a:txBody>
                    <a:bodyPr/>
                    <a:lstStyle/>
                    <a:p>
                      <a:pPr marL="0" defTabSz="1320759" rtl="0" eaLnBrk="1" latinLnBrk="0" hangingPunct="1"/>
                      <a:r>
                        <a:rPr lang="en-US" sz="1200" u="none" kern="100" dirty="0">
                          <a:solidFill>
                            <a:schemeClr val="tx1"/>
                          </a:solidFill>
                          <a:effectLst/>
                        </a:rPr>
                        <a:t>55.36 %</a:t>
                      </a:r>
                      <a:endParaRPr lang="zh-TW" altLang="en-US" sz="1200" u="none" kern="1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7478" marR="47478" marT="0" marB="0"/>
                </a:tc>
                <a:extLst>
                  <a:ext uri="{0D108BD9-81ED-4DB2-BD59-A6C34878D82A}">
                    <a16:rowId xmlns:a16="http://schemas.microsoft.com/office/drawing/2014/main" val="4015159001"/>
                  </a:ext>
                </a:extLst>
              </a:tr>
            </a:tbl>
          </a:graphicData>
        </a:graphic>
      </p:graphicFrame>
      <p:sp>
        <p:nvSpPr>
          <p:cNvPr id="13" name="文字方塊 12">
            <a:extLst>
              <a:ext uri="{FF2B5EF4-FFF2-40B4-BE49-F238E27FC236}">
                <a16:creationId xmlns:a16="http://schemas.microsoft.com/office/drawing/2014/main" id="{CCBDA680-8025-6CD1-D800-687575892CC0}"/>
              </a:ext>
            </a:extLst>
          </p:cNvPr>
          <p:cNvSpPr txBox="1"/>
          <p:nvPr/>
        </p:nvSpPr>
        <p:spPr>
          <a:xfrm>
            <a:off x="838200" y="5090229"/>
            <a:ext cx="2488826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46" dirty="0"/>
              <a:t>(c) Calculated by vertical axis</a:t>
            </a:r>
            <a:endParaRPr lang="zh-TW" altLang="en-US" sz="1246" dirty="0"/>
          </a:p>
        </p:txBody>
      </p:sp>
    </p:spTree>
    <p:extLst>
      <p:ext uri="{BB962C8B-B14F-4D97-AF65-F5344CB8AC3E}">
        <p14:creationId xmlns:p14="http://schemas.microsoft.com/office/powerpoint/2010/main" val="3100880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4</Words>
  <Application>Microsoft Office PowerPoint</Application>
  <PresentationFormat>寬螢幕</PresentationFormat>
  <Paragraphs>8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佈景主題</vt:lpstr>
      <vt:lpstr>Supplement Table 4. Pixel-level confusion matrix. (a) count by pixel. (b) Calculated by longitudinal axis. Most of the mis-classified pixels for ground truth were classified as background. (c) Calculated by vertical axis. Most of the mis-classified pixels for label were classified as background, but P and ENE has more cross-mistake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 Table 4. Pixel-level confusion matrix. (a) count by pixel. (b) Calculated by longitudinal axis. Most of the mis-classified pixels for ground truth were classified as background. (c) Calculated by vertical axis. Most of the mis-classified pixels for label were classified as background, but P and ENE has more cross-mistake.</dc:title>
  <dc:creator>聖耀 黃</dc:creator>
  <cp:lastModifiedBy>聖耀 黃</cp:lastModifiedBy>
  <cp:revision>1</cp:revision>
  <dcterms:created xsi:type="dcterms:W3CDTF">2023-09-12T09:05:48Z</dcterms:created>
  <dcterms:modified xsi:type="dcterms:W3CDTF">2023-09-12T09:06:18Z</dcterms:modified>
</cp:coreProperties>
</file>